
<file path=[Content_Types].xml><?xml version="1.0" encoding="utf-8"?>
<Types xmlns="http://schemas.openxmlformats.org/package/2006/content-types">
  <Default Extension="png" ContentType="image/png"/>
  <Default Extension="mov" ContentType="video/quicktime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8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3653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1301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816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999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2119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4335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8756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9144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1026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4079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614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441B1-A517-4516-BE21-F5888F5D476B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56B14-4E5A-4A9C-A300-0A067C0E52D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4277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2.mov"/><Relationship Id="rId7" Type="http://schemas.openxmlformats.org/officeDocument/2006/relationships/image" Target="../media/image2.png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3127389-B735-4A4C-B66A-78AAAF3161FB}"/>
              </a:ext>
            </a:extLst>
          </p:cNvPr>
          <p:cNvSpPr txBox="1"/>
          <p:nvPr/>
        </p:nvSpPr>
        <p:spPr>
          <a:xfrm>
            <a:off x="-62753" y="4686251"/>
            <a:ext cx="12191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it-IT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s </a:t>
            </a:r>
          </a:p>
          <a:p>
            <a:pPr algn="ctr"/>
            <a:r>
              <a:rPr lang="it-IT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igure 2)</a:t>
            </a:r>
            <a:endParaRPr lang="it-IT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8C6C436-16E9-2245-8684-BAB4AE11FE90}"/>
              </a:ext>
            </a:extLst>
          </p:cNvPr>
          <p:cNvSpPr txBox="1"/>
          <p:nvPr/>
        </p:nvSpPr>
        <p:spPr>
          <a:xfrm>
            <a:off x="1241610" y="370839"/>
            <a:ext cx="9583271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UNNELING NANOTUBES CONNECT BLOOD-BRAIN BARRIER CELLS: ROLE OF PERICYTES IN BARRIER PRESERVATION DURING ISCHEMIA</a:t>
            </a:r>
          </a:p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rancesco Pisani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2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,</a:t>
            </a:r>
            <a:r>
              <a:rPr lang="it-IT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Valentina Castagnola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,3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, Laura Simone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Fabrizio Loiacono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Maria Svelto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5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Fabio Benfenati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,3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US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partment of Biosciences, Biotechnologies and Biopharmaceutics, University of Bari “Aldo Moro”, Bari, Italy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nter for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ynaptic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euroscience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Technology, Istituto Italiano di Tecnologia, Genova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RCCS Ospedale Policlinico San Martino, Genova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ndazione IRCCS Casa Sollievo della Sofferenza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ncer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m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Unit, San Giovanni Rotondo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stitute of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iomembranes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Bioenergetics, National Research Council, Bari, Italy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National Institute of Biostructures and Biosystems, Rome, </a:t>
            </a:r>
            <a:r>
              <a:rPr lang="en-US" sz="16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24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Series053_AdjustClr002_Crop002">
            <a:hlinkClick r:id="" action="ppaction://media"/>
            <a:extLst>
              <a:ext uri="{FF2B5EF4-FFF2-40B4-BE49-F238E27FC236}">
                <a16:creationId xmlns:a16="http://schemas.microsoft.com/office/drawing/2014/main" id="{51C5CA4C-6540-AB4F-831E-EFF31E55D7F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69701" y="1998408"/>
            <a:ext cx="4778331" cy="4752503"/>
          </a:xfrm>
          <a:prstGeom prst="rect">
            <a:avLst/>
          </a:prstGeom>
        </p:spPr>
      </p:pic>
      <p:pic>
        <p:nvPicPr>
          <p:cNvPr id="12" name="hCMEC MitoDR e NHA 48ORE Series101_Crop001_AdjustClr001">
            <a:hlinkClick r:id="" action="ppaction://media"/>
            <a:extLst>
              <a:ext uri="{FF2B5EF4-FFF2-40B4-BE49-F238E27FC236}">
                <a16:creationId xmlns:a16="http://schemas.microsoft.com/office/drawing/2014/main" id="{812C2CA5-87CD-EF42-BD35-06DC685E462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>
            <a:lum bright="9000" contrast="52000"/>
          </a:blip>
          <a:srcRect/>
          <a:stretch/>
        </p:blipFill>
        <p:spPr>
          <a:xfrm>
            <a:off x="6743970" y="1920514"/>
            <a:ext cx="5163597" cy="4918772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F584D465-8716-4540-9850-7B5B6819D379}"/>
              </a:ext>
            </a:extLst>
          </p:cNvPr>
          <p:cNvSpPr txBox="1"/>
          <p:nvPr/>
        </p:nvSpPr>
        <p:spPr>
          <a:xfrm>
            <a:off x="9172731" y="1948268"/>
            <a:ext cx="1638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err="1">
                <a:solidFill>
                  <a:srgbClr val="FF0000"/>
                </a:solidFill>
              </a:rPr>
              <a:t>Endothelial</a:t>
            </a:r>
            <a:r>
              <a:rPr lang="it-IT" dirty="0">
                <a:solidFill>
                  <a:srgbClr val="FF0000"/>
                </a:solidFill>
              </a:rPr>
              <a:t> </a:t>
            </a:r>
          </a:p>
          <a:p>
            <a:pPr algn="ctr"/>
            <a:r>
              <a:rPr lang="it-IT" dirty="0" err="1">
                <a:solidFill>
                  <a:srgbClr val="FF0000"/>
                </a:solidFill>
              </a:rPr>
              <a:t>mitochondria</a:t>
            </a:r>
            <a:endParaRPr lang="it-IT" dirty="0">
              <a:solidFill>
                <a:srgbClr val="FF0000"/>
              </a:solidFill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7C3E5CB4-9E54-0D47-BB5C-88BE90F50B14}"/>
              </a:ext>
            </a:extLst>
          </p:cNvPr>
          <p:cNvSpPr txBox="1"/>
          <p:nvPr/>
        </p:nvSpPr>
        <p:spPr>
          <a:xfrm>
            <a:off x="2010929" y="2221306"/>
            <a:ext cx="26932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err="1">
                <a:solidFill>
                  <a:schemeClr val="bg1"/>
                </a:solidFill>
              </a:rPr>
              <a:t>Astro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CE032152-54A3-814F-9126-FB03678C4779}"/>
              </a:ext>
            </a:extLst>
          </p:cNvPr>
          <p:cNvSpPr txBox="1"/>
          <p:nvPr/>
        </p:nvSpPr>
        <p:spPr>
          <a:xfrm>
            <a:off x="766699" y="6043025"/>
            <a:ext cx="36349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0" b="1" dirty="0" err="1">
                <a:solidFill>
                  <a:schemeClr val="bg1"/>
                </a:solidFill>
              </a:rPr>
              <a:t>Endothelial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6D227498-858D-B94A-8454-F43044B0A9FD}"/>
              </a:ext>
            </a:extLst>
          </p:cNvPr>
          <p:cNvSpPr txBox="1"/>
          <p:nvPr/>
        </p:nvSpPr>
        <p:spPr>
          <a:xfrm>
            <a:off x="816492" y="2086768"/>
            <a:ext cx="1075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highlight>
                  <a:srgbClr val="FFFF00"/>
                </a:highlight>
              </a:rPr>
              <a:t>Movie </a:t>
            </a:r>
            <a:r>
              <a:rPr lang="it-IT" b="1" dirty="0">
                <a:highlight>
                  <a:srgbClr val="FFFF00"/>
                </a:highlight>
              </a:rPr>
              <a:t>#8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DB7DDEB2-BF8B-6041-B007-E6DD5C29BC83}"/>
              </a:ext>
            </a:extLst>
          </p:cNvPr>
          <p:cNvSpPr txBox="1"/>
          <p:nvPr/>
        </p:nvSpPr>
        <p:spPr>
          <a:xfrm>
            <a:off x="6795709" y="1995540"/>
            <a:ext cx="1075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highlight>
                  <a:srgbClr val="FFFF00"/>
                </a:highlight>
              </a:rPr>
              <a:t>Movie </a:t>
            </a:r>
            <a:r>
              <a:rPr lang="it-IT" b="1" dirty="0">
                <a:highlight>
                  <a:srgbClr val="FFFF00"/>
                </a:highlight>
              </a:rPr>
              <a:t>#9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717F7A98-59A3-6446-BF71-6F71589D715B}"/>
              </a:ext>
            </a:extLst>
          </p:cNvPr>
          <p:cNvSpPr txBox="1"/>
          <p:nvPr/>
        </p:nvSpPr>
        <p:spPr>
          <a:xfrm>
            <a:off x="6752262" y="3803294"/>
            <a:ext cx="26932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err="1">
                <a:solidFill>
                  <a:schemeClr val="bg1"/>
                </a:solidFill>
              </a:rPr>
              <a:t>Astro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cxnSp>
        <p:nvCxnSpPr>
          <p:cNvPr id="11" name="Connettore 1 10">
            <a:extLst>
              <a:ext uri="{FF2B5EF4-FFF2-40B4-BE49-F238E27FC236}">
                <a16:creationId xmlns:a16="http://schemas.microsoft.com/office/drawing/2014/main" id="{04CF923E-AE6C-EF4F-A911-14656B506DF4}"/>
              </a:ext>
            </a:extLst>
          </p:cNvPr>
          <p:cNvCxnSpPr>
            <a:cxnSpLocks/>
          </p:cNvCxnSpPr>
          <p:nvPr/>
        </p:nvCxnSpPr>
        <p:spPr>
          <a:xfrm flipV="1">
            <a:off x="9445464" y="2323273"/>
            <a:ext cx="2425062" cy="975296"/>
          </a:xfrm>
          <a:prstGeom prst="line">
            <a:avLst/>
          </a:prstGeom>
          <a:ln w="3810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45EB8220-BA19-DC46-BA31-E2633DDF85BC}"/>
              </a:ext>
            </a:extLst>
          </p:cNvPr>
          <p:cNvSpPr txBox="1"/>
          <p:nvPr/>
        </p:nvSpPr>
        <p:spPr>
          <a:xfrm>
            <a:off x="10341385" y="2893251"/>
            <a:ext cx="7777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>
                <a:solidFill>
                  <a:srgbClr val="FFFF00"/>
                </a:solidFill>
              </a:rPr>
              <a:t>TNT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0469EDD-DEB2-C34A-BAC4-04C98F7F1708}"/>
              </a:ext>
            </a:extLst>
          </p:cNvPr>
          <p:cNvSpPr txBox="1"/>
          <p:nvPr/>
        </p:nvSpPr>
        <p:spPr>
          <a:xfrm>
            <a:off x="1714791" y="1563522"/>
            <a:ext cx="22671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800" b="1" dirty="0"/>
              <a:t>Direct </a:t>
            </a:r>
            <a:r>
              <a:rPr lang="it-IT" sz="2800" b="1" dirty="0" err="1"/>
              <a:t>contact</a:t>
            </a:r>
            <a:endParaRPr lang="it-IT" sz="2800" b="1" dirty="0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D7D5555B-630B-744B-A09D-EFA98B1307DF}"/>
              </a:ext>
            </a:extLst>
          </p:cNvPr>
          <p:cNvSpPr txBox="1"/>
          <p:nvPr/>
        </p:nvSpPr>
        <p:spPr>
          <a:xfrm>
            <a:off x="0" y="-2250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Endothelial cells transfer functional mitochondria to astrocytes through direct contact and tunneling nanotubes (TNT)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7497EE2-F305-C942-8BB5-311503E74B11}"/>
              </a:ext>
            </a:extLst>
          </p:cNvPr>
          <p:cNvSpPr txBox="1"/>
          <p:nvPr/>
        </p:nvSpPr>
        <p:spPr>
          <a:xfrm>
            <a:off x="9172731" y="1490815"/>
            <a:ext cx="77777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800" b="1" dirty="0"/>
              <a:t>TNT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2E1C83A-736D-B445-8183-FE96C1280265}"/>
              </a:ext>
            </a:extLst>
          </p:cNvPr>
          <p:cNvSpPr txBox="1"/>
          <p:nvPr/>
        </p:nvSpPr>
        <p:spPr>
          <a:xfrm>
            <a:off x="1" y="1100372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 err="1">
                <a:solidFill>
                  <a:srgbClr val="FF0000"/>
                </a:solidFill>
              </a:rPr>
              <a:t>Endothelial</a:t>
            </a:r>
            <a:r>
              <a:rPr lang="it-IT" sz="2400" b="1" dirty="0">
                <a:solidFill>
                  <a:srgbClr val="FF0000"/>
                </a:solidFill>
              </a:rPr>
              <a:t> </a:t>
            </a:r>
            <a:r>
              <a:rPr lang="it-IT" sz="2400" b="1" dirty="0" err="1">
                <a:solidFill>
                  <a:srgbClr val="FF0000"/>
                </a:solidFill>
              </a:rPr>
              <a:t>mitochondria</a:t>
            </a:r>
            <a:r>
              <a:rPr lang="it-IT" sz="2400" b="1" dirty="0">
                <a:solidFill>
                  <a:srgbClr val="FF0000"/>
                </a:solidFill>
              </a:rPr>
              <a:t>/</a:t>
            </a:r>
            <a:r>
              <a:rPr lang="it-IT" sz="2400" b="1" dirty="0" err="1">
                <a:solidFill>
                  <a:srgbClr val="2646B3"/>
                </a:solidFill>
              </a:rPr>
              <a:t>Astrocytes</a:t>
            </a:r>
            <a:r>
              <a:rPr lang="it-IT" sz="2400" b="1" dirty="0">
                <a:solidFill>
                  <a:srgbClr val="2646B3"/>
                </a:solidFill>
              </a:rPr>
              <a:t> Cell-</a:t>
            </a:r>
            <a:r>
              <a:rPr lang="it-IT" sz="2400" b="1" dirty="0" err="1">
                <a:solidFill>
                  <a:srgbClr val="2646B3"/>
                </a:solidFill>
              </a:rPr>
              <a:t>Mask</a:t>
            </a:r>
            <a:r>
              <a:rPr lang="it-IT" sz="2400" b="1" dirty="0">
                <a:solidFill>
                  <a:srgbClr val="2646B3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614209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9666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9666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50666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fill="remove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6" fill="remove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6243615CEA0024BBCBBB65F1F6BD069" ma:contentTypeVersion="14" ma:contentTypeDescription="Creare un nuovo documento." ma:contentTypeScope="" ma:versionID="a625b094cccbf6977b64d2084137dc60">
  <xsd:schema xmlns:xsd="http://www.w3.org/2001/XMLSchema" xmlns:xs="http://www.w3.org/2001/XMLSchema" xmlns:p="http://schemas.microsoft.com/office/2006/metadata/properties" xmlns:ns3="db5dbd57-83cc-4b67-bfb6-19657461690e" xmlns:ns4="acfa8718-ee53-414b-ab15-01c7f90c0029" targetNamespace="http://schemas.microsoft.com/office/2006/metadata/properties" ma:root="true" ma:fieldsID="99e8c7a4788a4550be9a14547ed8cbb5" ns3:_="" ns4:_="">
    <xsd:import namespace="db5dbd57-83cc-4b67-bfb6-19657461690e"/>
    <xsd:import namespace="acfa8718-ee53-414b-ab15-01c7f90c0029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b5dbd57-83cc-4b67-bfb6-19657461690e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cfa8718-ee53-414b-ab15-01c7f90c00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378E586-415E-45FE-A0B6-50C12C9D03B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b5dbd57-83cc-4b67-bfb6-19657461690e"/>
    <ds:schemaRef ds:uri="acfa8718-ee53-414b-ab15-01c7f90c00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275DA3C-ABF3-4009-A12C-56BA1E2FF0B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01D36EC-4B32-48BF-9049-B4B80A4F0212}">
  <ds:schemaRefs>
    <ds:schemaRef ds:uri="http://purl.org/dc/elements/1.1/"/>
    <ds:schemaRef ds:uri="http://schemas.microsoft.com/office/2006/metadata/properties"/>
    <ds:schemaRef ds:uri="db5dbd57-83cc-4b67-bfb6-19657461690e"/>
    <ds:schemaRef ds:uri="acfa8718-ee53-414b-ab15-01c7f90c0029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8</Words>
  <Application>Microsoft Office PowerPoint</Application>
  <PresentationFormat>Widescreen</PresentationFormat>
  <Paragraphs>23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 Castagnola</dc:creator>
  <cp:lastModifiedBy>Valentina Castagnola</cp:lastModifiedBy>
  <cp:revision>1</cp:revision>
  <dcterms:created xsi:type="dcterms:W3CDTF">2022-03-02T16:01:43Z</dcterms:created>
  <dcterms:modified xsi:type="dcterms:W3CDTF">2022-03-02T16:02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6243615CEA0024BBCBBB65F1F6BD069</vt:lpwstr>
  </property>
</Properties>
</file>